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038" autoAdjust="0"/>
  </p:normalViewPr>
  <p:slideViewPr>
    <p:cSldViewPr snapToObjects="1">
      <p:cViewPr varScale="1">
        <p:scale>
          <a:sx n="71" d="100"/>
          <a:sy n="71" d="100"/>
        </p:scale>
        <p:origin x="-169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EBDA4-3C33-49D5-9219-FF165DA8C62E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5BA6CE-5B46-4A88-82C9-55BDE7F1F2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780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7: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vestigator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the expression profile of Arabidopsis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MR1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A) Tissue specific expression levels across different floral tissues. B) Development stage specific expression levels.</a:t>
            </a:r>
          </a:p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5BA6CE-5B46-4A88-82C9-55BDE7F1F21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9848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082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0418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385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28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965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976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40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125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686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8112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632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50832-8E73-424C-B8A9-E7DBF199EA11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14C93-4A83-4D4E-BB2E-8B9F3A2561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4758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\\pepper\homestd\My Documents\homoserine manuscript\dmr1 expression tissues.g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73" b="2881"/>
          <a:stretch/>
        </p:blipFill>
        <p:spPr bwMode="auto">
          <a:xfrm>
            <a:off x="332656" y="107505"/>
            <a:ext cx="6365875" cy="44242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\\pepper\homestd\My Documents\homoserine manuscript\dmr1 expression development.g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20"/>
          <a:stretch/>
        </p:blipFill>
        <p:spPr bwMode="auto">
          <a:xfrm>
            <a:off x="1772816" y="4427984"/>
            <a:ext cx="4384675" cy="4587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35112" y="53955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2066392" y="4537185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4593250"/>
            <a:ext cx="2066392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GB" sz="1400" dirty="0" smtClean="0"/>
              <a:t>GENEVESTIGATOR </a:t>
            </a:r>
            <a:r>
              <a:rPr lang="en-GB" sz="1400" dirty="0"/>
              <a:t>analysis of the expression profile of Arabidopsis </a:t>
            </a:r>
            <a:r>
              <a:rPr lang="en-GB" sz="1400" i="1" dirty="0"/>
              <a:t>DMR1</a:t>
            </a:r>
            <a:r>
              <a:rPr lang="en-GB" sz="1400" dirty="0"/>
              <a:t>. A) Tissue specific expression levels across different floral tissues. B) Development stage specific expression levels.</a:t>
            </a:r>
          </a:p>
        </p:txBody>
      </p:sp>
    </p:spTree>
    <p:extLst>
      <p:ext uri="{BB962C8B-B14F-4D97-AF65-F5344CB8AC3E}">
        <p14:creationId xmlns:p14="http://schemas.microsoft.com/office/powerpoint/2010/main" val="2355907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5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4</cp:revision>
  <dcterms:created xsi:type="dcterms:W3CDTF">2014-03-19T12:47:48Z</dcterms:created>
  <dcterms:modified xsi:type="dcterms:W3CDTF">2014-12-03T14:36:55Z</dcterms:modified>
</cp:coreProperties>
</file>